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40" d="100"/>
          <a:sy n="140" d="100"/>
        </p:scale>
        <p:origin x="-852" y="9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737" y="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/>
          <a:lstStyle>
            <a:lvl1pPr algn="r">
              <a:defRPr sz="1200"/>
            </a:lvl1pPr>
          </a:lstStyle>
          <a:p>
            <a:fld id="{0C94D679-86A5-444D-8352-038A242B7AA5}" type="datetimeFigureOut">
              <a:rPr lang="en-CA" smtClean="0"/>
              <a:t>2017-02-0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04" tIns="47352" rIns="94704" bIns="47352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0859" y="4559916"/>
            <a:ext cx="5853483" cy="4320867"/>
          </a:xfrm>
          <a:prstGeom prst="rect">
            <a:avLst/>
          </a:prstGeom>
        </p:spPr>
        <p:txBody>
          <a:bodyPr vert="horz" lIns="94704" tIns="47352" rIns="94704" bIns="4735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83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737" y="9119830"/>
            <a:ext cx="3169810" cy="479733"/>
          </a:xfrm>
          <a:prstGeom prst="rect">
            <a:avLst/>
          </a:prstGeom>
        </p:spPr>
        <p:txBody>
          <a:bodyPr vert="horz" lIns="94704" tIns="47352" rIns="94704" bIns="47352" rtlCol="0" anchor="b"/>
          <a:lstStyle>
            <a:lvl1pPr algn="r">
              <a:defRPr sz="1200"/>
            </a:lvl1pPr>
          </a:lstStyle>
          <a:p>
            <a:fld id="{ACD6559C-E1B9-4EBC-8516-7C7724E779A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0572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D2561-4133-4350-BC8C-ABFE60F8C53F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413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ACCCF-E931-42B6-81EC-DF79F700D95A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965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F6383C-328D-4048-AE9E-2E46D75D8C77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687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3B0E6-D34C-4A69-9A78-4926FBA0B0A1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803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5A97-DF27-40C2-9432-5BE375F21439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04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9CB97-8EB4-4980-99E9-FDDB8E219648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696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707DD-E821-4F7B-9001-D86B06916914}" type="datetime1">
              <a:rPr lang="en-US" smtClean="0"/>
              <a:t>2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489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064F5E-DF64-48F9-95F9-156FF0A4C0A7}" type="datetime1">
              <a:rPr lang="en-US" smtClean="0"/>
              <a:t>2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910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37164-949A-4FA1-B387-0F1227248824}" type="datetime1">
              <a:rPr lang="en-US" smtClean="0"/>
              <a:t>2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17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87F7-5499-4339-B0AE-4CF173FF1E86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16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25917-9968-4E14-A5CC-E3F082F69F88}" type="datetime1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499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2B648-2815-4CC7-B17D-A00AFB5B0973}" type="datetime1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79DA4-2EA1-694C-BDAA-6C9D82C788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343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76708" y="267439"/>
            <a:ext cx="6366296" cy="4998546"/>
            <a:chOff x="1276708" y="646983"/>
            <a:chExt cx="6366296" cy="4998546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34" t="33651"/>
            <a:stretch/>
          </p:blipFill>
          <p:spPr bwMode="auto">
            <a:xfrm>
              <a:off x="1276708" y="646983"/>
              <a:ext cx="6366296" cy="38915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36830" y="4581640"/>
              <a:ext cx="2613805" cy="460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07820" y="5185742"/>
              <a:ext cx="2551437" cy="459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" name="Rectangle 2"/>
          <p:cNvSpPr/>
          <p:nvPr/>
        </p:nvSpPr>
        <p:spPr>
          <a:xfrm>
            <a:off x="577968" y="5265985"/>
            <a:ext cx="8376252" cy="9417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CA" sz="1200" b="1" dirty="0" smtClean="0">
                <a:latin typeface="Times New Roman"/>
                <a:ea typeface="Calibri"/>
                <a:cs typeface="Times New Roman"/>
              </a:rPr>
              <a:t>S3 Fig</a:t>
            </a:r>
            <a:r>
              <a:rPr lang="en-CA" sz="1200" dirty="0" smtClean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BLAST matrix of proteomes of five strains of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Clavibacter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michiganensi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 subspecies based on all against protein comparison to define homologs. A hit is considered significant if 50%/50% (identity/length coverage) requirement between-proteomes is met. Paralogs (internal homology) are proteins within a genome matching the same 50–50 rule. </a:t>
            </a:r>
            <a:r>
              <a:rPr lang="en-CA" sz="1200" dirty="0" err="1">
                <a:latin typeface="Times New Roman"/>
                <a:ea typeface="Calibri"/>
                <a:cs typeface="Times New Roman"/>
              </a:rPr>
              <a:t>Cm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, 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C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michiganesis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subsp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sepedonicu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; </a:t>
            </a:r>
            <a:r>
              <a:rPr lang="en-CA" sz="1200" dirty="0" err="1">
                <a:latin typeface="Times New Roman"/>
                <a:ea typeface="Calibri"/>
                <a:cs typeface="Times New Roman"/>
              </a:rPr>
              <a:t>Cmn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, 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C. m.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subsp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nebraskensi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 ; </a:t>
            </a:r>
            <a:r>
              <a:rPr lang="en-CA" sz="1200" dirty="0" err="1">
                <a:latin typeface="Times New Roman"/>
                <a:ea typeface="Calibri"/>
                <a:cs typeface="Times New Roman"/>
              </a:rPr>
              <a:t>Cmm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, 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C. m.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subsp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michiganensi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;  </a:t>
            </a:r>
            <a:r>
              <a:rPr lang="en-CA" sz="1200" dirty="0" err="1">
                <a:latin typeface="Times New Roman"/>
                <a:ea typeface="Calibri"/>
                <a:cs typeface="Times New Roman"/>
              </a:rPr>
              <a:t>Cmi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, 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C. m.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subsp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insidiosus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; 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C. m. 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subsp</a:t>
            </a:r>
            <a:r>
              <a:rPr lang="en-CA" sz="1200" i="1" dirty="0">
                <a:latin typeface="Times New Roman"/>
                <a:ea typeface="Calibri"/>
                <a:cs typeface="Times New Roman"/>
              </a:rPr>
              <a:t>. </a:t>
            </a:r>
            <a:r>
              <a:rPr lang="en-CA" sz="1200" i="1" dirty="0" err="1">
                <a:latin typeface="Times New Roman"/>
                <a:ea typeface="Calibri"/>
                <a:cs typeface="Times New Roman"/>
              </a:rPr>
              <a:t>capsici</a:t>
            </a:r>
            <a:r>
              <a:rPr lang="en-CA" sz="1200" dirty="0">
                <a:latin typeface="Times New Roman"/>
                <a:ea typeface="Calibri"/>
                <a:cs typeface="Times New Roman"/>
              </a:rPr>
              <a:t>.</a:t>
            </a:r>
            <a:endParaRPr lang="en-CA" sz="12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97084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0</TotalTime>
  <Words>7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AF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Tambong</dc:creator>
  <cp:lastModifiedBy>Tambong, James</cp:lastModifiedBy>
  <cp:revision>98</cp:revision>
  <cp:lastPrinted>2016-11-30T21:42:56Z</cp:lastPrinted>
  <dcterms:created xsi:type="dcterms:W3CDTF">2016-09-28T20:03:55Z</dcterms:created>
  <dcterms:modified xsi:type="dcterms:W3CDTF">2017-02-07T18:20:28Z</dcterms:modified>
</cp:coreProperties>
</file>